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  <p:sldId id="261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68CF05-75CE-D81B-3958-011A73ED1A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4D0A9B5-4BAF-AA20-AD4F-5445568728F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AA4643-CEAB-ED4A-81F1-B042D40928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7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D0ED0D-4A3D-4FAA-F91B-CD55D9E1EB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12B51B-2E43-599A-6838-96430361FF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3544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773E9B-D4E7-E346-FB50-A41E0B8EFA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D8F6E18-6FA5-C8C9-870D-6A40E72E8E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61A1AC-85A5-56DF-9A62-FAA70B9314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7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2957D5-0C61-5DC0-82FB-9F74D60DCB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A46975-8E45-40EA-B91B-BBA29D6791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67533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FD2956C-9585-C3A7-A934-74CA05A15B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7EE2285-6BCE-8D45-2114-06BAE74C26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FAA9F5-51A9-258E-4259-FFF3297571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7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89E6E3-3081-0DF3-9135-FED78B9762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18B459-4246-5546-2666-46848F6AAE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582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B312D5-92DA-D71D-E7FF-1185C57EFC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493AC3-5838-5686-979F-C4708EAB9D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FBCBBE-C65A-1D9B-06AB-5A8291712B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7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5BD418-50AA-195E-9EF7-D37BD96474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13E518-5ACE-5576-44E5-BE929C49DE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11908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2AAB84-091F-22D5-3A6C-2DC3AAC4CA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D6B9BA-F627-D1E2-DB31-4985C5D271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EE6CB2-E836-6A59-C64E-F2318B43FB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7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61097C-65E4-6523-D969-7CCE35A75B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D3D516-7B6B-8815-EB85-192C470E32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10001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1145D4-4F3E-DEF0-E52D-6F199945E7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F7D364-D78F-5285-CFE5-28351C6CCBC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2EEA0D-DFDD-70C7-2A63-AED7EAD1A1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E2DA67F-4A1E-0861-4C09-6E66646B35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7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3E79AA-DD26-89CD-01CC-9892E84063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6D811C-07A8-0FBC-47D4-89DD4BA7BF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09103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B44007-89BB-BD77-871F-B1AA48E1B0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7168E8-01A6-B85D-F9AE-23C401953B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F7D23E6-9139-D575-2CCF-25C6647438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19A8250-CF1B-3354-0556-08C73340F4E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845D328-D506-2928-BAF0-05A9108B5A9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6F467DC-86FD-CA63-923D-03A7C1B094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7/06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14FF3B5-B688-9692-22E2-A444F44CC1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097691A-9CD4-1274-14E1-AC55E5585D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80716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866D0E-AD11-EA47-B1DC-01D7E0AA51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15D4909-405A-165D-103C-1D7E95FD70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7/06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44D9572-0B1D-FE6F-EF95-F5E64844DF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BBEEC9F-7990-93B9-A120-28D153D8BC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60033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0903C99-819D-1F44-9492-1432839191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7/06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93F52CA-9FF0-30C6-E2D9-60B1E91C39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9E4D404-9C29-4F76-6AAF-687EEF66B5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03461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456EAF-B526-28C9-72E1-15BAA3BE8D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D04110-9824-D35B-CF74-FFAA3E9565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6DC3187-603B-0CAB-38C7-E86921C0E7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0FA8D5-E6AF-0212-F67F-ACFA6DFF9C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7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E1AD6B2-B43E-F50B-56D6-3F52696257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916575-FF07-F808-8E6F-44012E5A04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85555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D2E2D0-C57B-03DC-8B59-6147D3F057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CE6B405-2A04-9B3F-CAFC-16C41782685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5BA778B-0D30-1763-F06E-00B2F19EF5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E4BFAF-71E0-16DE-2FD1-F17396541D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7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C6507B-296A-BE8A-004A-9B9C54CFED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494F8C-3B05-AC5F-D984-D5693E3AB3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21415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7508D78-3907-9E1F-6C27-99B43B6D19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AEB8E4-6EFD-207A-B4BB-B6258EB5D4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4AA7D4-7F64-B9D1-8B5C-9FF21ADEF1E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9FC2518-AE36-48D1-96F6-74333C097C54}" type="datetimeFigureOut">
              <a:rPr lang="en-GB" smtClean="0"/>
              <a:t>17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82A2B5-108F-6F70-32EE-A377B5418F7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E433AA-3D25-AA0B-0995-A503FFCDF5C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76518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7AC418E9-2AC5-006F-B03A-FEDA89C3B7F8}"/>
              </a:ext>
            </a:extLst>
          </p:cNvPr>
          <p:cNvSpPr txBox="1"/>
          <p:nvPr/>
        </p:nvSpPr>
        <p:spPr>
          <a:xfrm>
            <a:off x="686234" y="397584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p#1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2EB4046-3835-5259-EAEB-1C300DB6163A}"/>
              </a:ext>
            </a:extLst>
          </p:cNvPr>
          <p:cNvSpPr txBox="1"/>
          <p:nvPr/>
        </p:nvSpPr>
        <p:spPr>
          <a:xfrm>
            <a:off x="2552519" y="1354493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7183868-3A33-870B-9834-E90B67AF8C4F}"/>
              </a:ext>
            </a:extLst>
          </p:cNvPr>
          <p:cNvSpPr txBox="1"/>
          <p:nvPr/>
        </p:nvSpPr>
        <p:spPr>
          <a:xfrm>
            <a:off x="3377284" y="892828"/>
            <a:ext cx="261481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fractionated CM&gt;10kDa</a:t>
            </a:r>
          </a:p>
          <a:p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7D401964-11F1-D2E9-F955-E0346753F145}"/>
              </a:ext>
            </a:extLst>
          </p:cNvPr>
          <p:cNvCxnSpPr/>
          <p:nvPr/>
        </p:nvCxnSpPr>
        <p:spPr>
          <a:xfrm>
            <a:off x="3676626" y="1281341"/>
            <a:ext cx="18578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6" name="Picture 5">
            <a:extLst>
              <a:ext uri="{FF2B5EF4-FFF2-40B4-BE49-F238E27FC236}">
                <a16:creationId xmlns:a16="http://schemas.microsoft.com/office/drawing/2014/main" id="{04464BFD-B706-A152-7DAE-F79AECA958E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1018928" y="3072486"/>
            <a:ext cx="3600000" cy="11550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96CB481E-73E6-D54E-55C9-5093D6C50F8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2385822" y="3042391"/>
            <a:ext cx="3600000" cy="121519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5757D45E-878F-C524-4E83-AFB99007EC38}"/>
              </a:ext>
            </a:extLst>
          </p:cNvPr>
          <p:cNvSpPr txBox="1"/>
          <p:nvPr/>
        </p:nvSpPr>
        <p:spPr>
          <a:xfrm>
            <a:off x="3475723" y="1237249"/>
            <a:ext cx="142019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/>
              <a:t>room </a:t>
            </a:r>
          </a:p>
          <a:p>
            <a:pPr algn="ctr"/>
            <a:r>
              <a:rPr lang="en-GB" dirty="0"/>
              <a:t>temperature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68EC2C81-06AD-076C-511A-DBAA37ABE4D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5400000">
            <a:off x="3688405" y="3025959"/>
            <a:ext cx="3600000" cy="1215190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86BF0CF3-2C62-B5FB-4520-7BB17528F41A}"/>
              </a:ext>
            </a:extLst>
          </p:cNvPr>
          <p:cNvSpPr txBox="1"/>
          <p:nvPr/>
        </p:nvSpPr>
        <p:spPr>
          <a:xfrm>
            <a:off x="5268021" y="1375748"/>
            <a:ext cx="6767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95°C</a:t>
            </a:r>
          </a:p>
        </p:txBody>
      </p:sp>
    </p:spTree>
    <p:extLst>
      <p:ext uri="{BB962C8B-B14F-4D97-AF65-F5344CB8AC3E}">
        <p14:creationId xmlns:p14="http://schemas.microsoft.com/office/powerpoint/2010/main" val="10121297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7AC418E9-2AC5-006F-B03A-FEDA89C3B7F8}"/>
              </a:ext>
            </a:extLst>
          </p:cNvPr>
          <p:cNvSpPr txBox="1"/>
          <p:nvPr/>
        </p:nvSpPr>
        <p:spPr>
          <a:xfrm>
            <a:off x="686234" y="397584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p#2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0C4AD53-DF88-3C3C-0FD5-DED218515AE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1078369" y="3029719"/>
            <a:ext cx="3600000" cy="120766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B61CD80-3A0E-A073-1AF1-9C8F2A79DED7}"/>
              </a:ext>
            </a:extLst>
          </p:cNvPr>
          <p:cNvSpPr txBox="1"/>
          <p:nvPr/>
        </p:nvSpPr>
        <p:spPr>
          <a:xfrm>
            <a:off x="2552519" y="1354493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23D4657-F3F2-39B7-4443-BF36F5326849}"/>
              </a:ext>
            </a:extLst>
          </p:cNvPr>
          <p:cNvSpPr txBox="1"/>
          <p:nvPr/>
        </p:nvSpPr>
        <p:spPr>
          <a:xfrm>
            <a:off x="3377284" y="892828"/>
            <a:ext cx="261481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fractionated CM&gt;10kDa</a:t>
            </a:r>
          </a:p>
          <a:p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D1A9C868-8E5E-BAFF-C4E2-364EE267DE94}"/>
              </a:ext>
            </a:extLst>
          </p:cNvPr>
          <p:cNvCxnSpPr/>
          <p:nvPr/>
        </p:nvCxnSpPr>
        <p:spPr>
          <a:xfrm>
            <a:off x="3676626" y="1281341"/>
            <a:ext cx="18578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03F58E3F-6E78-15B3-EEBF-97EB5E95A208}"/>
              </a:ext>
            </a:extLst>
          </p:cNvPr>
          <p:cNvSpPr txBox="1"/>
          <p:nvPr/>
        </p:nvSpPr>
        <p:spPr>
          <a:xfrm>
            <a:off x="3475723" y="1237249"/>
            <a:ext cx="142019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/>
              <a:t>room </a:t>
            </a:r>
          </a:p>
          <a:p>
            <a:pPr algn="ctr"/>
            <a:r>
              <a:rPr lang="en-GB" dirty="0"/>
              <a:t>temperatur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B5EA8A6-2247-C32B-36CA-FB0DB98EED66}"/>
              </a:ext>
            </a:extLst>
          </p:cNvPr>
          <p:cNvSpPr txBox="1"/>
          <p:nvPr/>
        </p:nvSpPr>
        <p:spPr>
          <a:xfrm>
            <a:off x="5268021" y="1375748"/>
            <a:ext cx="6767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95°C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79306C60-56D9-BF57-0503-7EA1C04151C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2385820" y="3053709"/>
            <a:ext cx="3600000" cy="1209717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D4F42F26-3606-C9F3-3188-AA3574FABD1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32755"/>
          <a:stretch/>
        </p:blipFill>
        <p:spPr>
          <a:xfrm rot="5400000">
            <a:off x="4396000" y="2464123"/>
            <a:ext cx="2420827" cy="12097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757526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7AC418E9-2AC5-006F-B03A-FEDA89C3B7F8}"/>
              </a:ext>
            </a:extLst>
          </p:cNvPr>
          <p:cNvSpPr txBox="1"/>
          <p:nvPr/>
        </p:nvSpPr>
        <p:spPr>
          <a:xfrm>
            <a:off x="686234" y="397584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p#3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CDB2ED2-DAD9-851D-73E6-711935308E7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1018927" y="3016198"/>
            <a:ext cx="3600000" cy="123471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5775CEE-1DD3-8C1F-731A-8B475BD612D4}"/>
              </a:ext>
            </a:extLst>
          </p:cNvPr>
          <p:cNvSpPr txBox="1"/>
          <p:nvPr/>
        </p:nvSpPr>
        <p:spPr>
          <a:xfrm>
            <a:off x="2552519" y="1354493"/>
            <a:ext cx="5693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A7362B4-807D-822C-8B4A-FE69C3876F10}"/>
              </a:ext>
            </a:extLst>
          </p:cNvPr>
          <p:cNvSpPr txBox="1"/>
          <p:nvPr/>
        </p:nvSpPr>
        <p:spPr>
          <a:xfrm>
            <a:off x="3377284" y="892828"/>
            <a:ext cx="261481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fractionated CM&gt;10kDa</a:t>
            </a:r>
          </a:p>
          <a:p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260346D6-DECB-015B-4750-42EC7B9BCA00}"/>
              </a:ext>
            </a:extLst>
          </p:cNvPr>
          <p:cNvCxnSpPr/>
          <p:nvPr/>
        </p:nvCxnSpPr>
        <p:spPr>
          <a:xfrm>
            <a:off x="3676626" y="1281341"/>
            <a:ext cx="18578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AE0F95C1-6663-CFA1-EED6-3559BC28E6D9}"/>
              </a:ext>
            </a:extLst>
          </p:cNvPr>
          <p:cNvSpPr txBox="1"/>
          <p:nvPr/>
        </p:nvSpPr>
        <p:spPr>
          <a:xfrm>
            <a:off x="3475723" y="1237249"/>
            <a:ext cx="142019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dirty="0"/>
              <a:t>room </a:t>
            </a:r>
          </a:p>
          <a:p>
            <a:pPr algn="ctr"/>
            <a:r>
              <a:rPr lang="en-GB" dirty="0"/>
              <a:t>temperatur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C947102-AD9F-770E-AD83-BE9F5B1DB3CF}"/>
              </a:ext>
            </a:extLst>
          </p:cNvPr>
          <p:cNvSpPr txBox="1"/>
          <p:nvPr/>
        </p:nvSpPr>
        <p:spPr>
          <a:xfrm>
            <a:off x="5268021" y="1375748"/>
            <a:ext cx="6767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95°C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2B35C092-89BB-F851-F140-75995BF8E27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5400000">
            <a:off x="2406156" y="3014627"/>
            <a:ext cx="3600000" cy="1237855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7EEDA22B-0154-E65E-F743-2AAB9BB099E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5400000">
            <a:off x="3762601" y="3014627"/>
            <a:ext cx="3600000" cy="12378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139008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06</TotalTime>
  <Words>39</Words>
  <Application>Microsoft Office PowerPoint</Application>
  <PresentationFormat>Widescreen</PresentationFormat>
  <Paragraphs>1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obias Ackermann</dc:creator>
  <cp:lastModifiedBy>Tobias Ackermann</cp:lastModifiedBy>
  <cp:revision>21</cp:revision>
  <dcterms:created xsi:type="dcterms:W3CDTF">2024-06-06T16:34:22Z</dcterms:created>
  <dcterms:modified xsi:type="dcterms:W3CDTF">2024-06-17T15:46:03Z</dcterms:modified>
</cp:coreProperties>
</file>